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style16.xml" ContentType="application/vnd.ms-office.chartstyle+xml"/>
  <Override PartName="/ppt/charts/colors16.xml" ContentType="application/vnd.ms-office.chartcolorstyle+xml"/>
  <Override PartName="/ppt/charts/style17.xml" ContentType="application/vnd.ms-office.chartstyle+xml"/>
  <Override PartName="/ppt/charts/colors17.xml" ContentType="application/vnd.ms-office.chartcolorstyle+xml"/>
  <Override PartName="/ppt/charts/style18.xml" ContentType="application/vnd.ms-office.chartstyle+xml"/>
  <Override PartName="/ppt/charts/colors18.xml" ContentType="application/vnd.ms-office.chartcolorstyle+xml"/>
  <Override PartName="/ppt/charts/style19.xml" ContentType="application/vnd.ms-office.chartstyle+xml"/>
  <Override PartName="/ppt/charts/colors19.xml" ContentType="application/vnd.ms-office.chartcolor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2" r:id="rId2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7FF84"/>
    <a:srgbClr val="FBBEFF"/>
    <a:srgbClr val="FF8CCA"/>
    <a:srgbClr val="5D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84E427A-3D55-4303-BF80-6455036E1DE7}" styleName="Designformatvorlage 1 - Akz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840" autoAdjust="0"/>
    <p:restoredTop sz="96310" autoAdjust="0"/>
  </p:normalViewPr>
  <p:slideViewPr>
    <p:cSldViewPr>
      <p:cViewPr>
        <p:scale>
          <a:sx n="130" d="100"/>
          <a:sy n="130" d="100"/>
        </p:scale>
        <p:origin x="-2154" y="-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6.xml"/><Relationship Id="rId2" Type="http://schemas.microsoft.com/office/2011/relationships/chartColorStyle" Target="colors16.xml"/><Relationship Id="rId1" Type="http://schemas.openxmlformats.org/officeDocument/2006/relationships/oleObject" Target="file:///C:\Users\cmarx\Documents\Tox_AUY.xls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17.xml"/><Relationship Id="rId2" Type="http://schemas.microsoft.com/office/2011/relationships/chartColorStyle" Target="colors17.xml"/><Relationship Id="rId1" Type="http://schemas.openxmlformats.org/officeDocument/2006/relationships/oleObject" Target="file:///C:\Users\cmarx\Documents\Tox_VE.xls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Style" Target="style18.xml"/><Relationship Id="rId2" Type="http://schemas.microsoft.com/office/2011/relationships/chartColorStyle" Target="colors18.xml"/><Relationship Id="rId1" Type="http://schemas.openxmlformats.org/officeDocument/2006/relationships/oleObject" Target="file:///C:\Users\cmarx\Documents\209_Tox.xls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microsoft.com/office/2011/relationships/chartStyle" Target="style19.xml"/><Relationship Id="rId2" Type="http://schemas.microsoft.com/office/2011/relationships/chartColorStyle" Target="colors19.xml"/><Relationship Id="rId1" Type="http://schemas.openxmlformats.org/officeDocument/2006/relationships/oleObject" Target="file:///\\mexico\data\wang\homes\cmarx\Experiments\Mass%20Spectrometry\Proteomics%20A673\IPA\2nd%20analysis\A+V%20common%20tox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0!$A$3:$A$22</c:f>
              <c:strCache>
                <c:ptCount val="20"/>
                <c:pt idx="0">
                  <c:v>Decreases Depolarization of Mitochondria and Mitochondrial Membrane</c:v>
                </c:pt>
                <c:pt idx="1">
                  <c:v>NRF2-mediated Oxidative Stress Response</c:v>
                </c:pt>
                <c:pt idx="2">
                  <c:v>Aryl Hydrocarbon Receptor Signaling</c:v>
                </c:pt>
                <c:pt idx="3">
                  <c:v>Cell Cycle: G2/M DNA Damage Checkpoint Regulation</c:v>
                </c:pt>
                <c:pt idx="4">
                  <c:v>Mitochondrial Dysfunction</c:v>
                </c:pt>
                <c:pt idx="5">
                  <c:v>Fatty Acid Metabolism</c:v>
                </c:pt>
                <c:pt idx="6">
                  <c:v>Hypoxia-Inducible Factor Signaling</c:v>
                </c:pt>
                <c:pt idx="7">
                  <c:v>Decreases Permeability Transition of Mitochondria and Mitochondrial Membrane</c:v>
                </c:pt>
                <c:pt idx="8">
                  <c:v>Renal Necrosis/Cell Death</c:v>
                </c:pt>
                <c:pt idx="9">
                  <c:v>Increases Transmembrane Potential of Mitochondria and Mitochondrial Membrane</c:v>
                </c:pt>
                <c:pt idx="10">
                  <c:v>Genes Upregulated in Response to Proteinuria-induced Oxidative Stress in Renal Proximal Tubule Cells (Human)</c:v>
                </c:pt>
                <c:pt idx="11">
                  <c:v>Cholesterol Biosynthesis</c:v>
                </c:pt>
                <c:pt idx="12">
                  <c:v>Decreases Transmembrane Potential of Mitochondria and Mitochondrial Membrane</c:v>
                </c:pt>
                <c:pt idx="13">
                  <c:v>Renal Safety Biomarker Panel (PSTC)</c:v>
                </c:pt>
                <c:pt idx="14">
                  <c:v>p53 Signaling</c:v>
                </c:pt>
                <c:pt idx="15">
                  <c:v>Liver Necrosis/Cell Death</c:v>
                </c:pt>
                <c:pt idx="16">
                  <c:v>PPARα/RXRα Activation</c:v>
                </c:pt>
                <c:pt idx="17">
                  <c:v>Acute Renal Failure Panel (Rat)</c:v>
                </c:pt>
                <c:pt idx="18">
                  <c:v>Cardiac Necrosis/Cell Death</c:v>
                </c:pt>
                <c:pt idx="19">
                  <c:v>Primary Glomerulonephritis Biomarker Panel (Human)</c:v>
                </c:pt>
              </c:strCache>
            </c:strRef>
          </c:cat>
          <c:val>
            <c:numRef>
              <c:f>Sheet0!$B$3:$B$22</c:f>
              <c:numCache>
                <c:formatCode>General</c:formatCode>
                <c:ptCount val="20"/>
                <c:pt idx="0">
                  <c:v>7.62</c:v>
                </c:pt>
                <c:pt idx="1">
                  <c:v>6.75</c:v>
                </c:pt>
                <c:pt idx="2">
                  <c:v>4.97</c:v>
                </c:pt>
                <c:pt idx="3">
                  <c:v>4.8600000000000003</c:v>
                </c:pt>
                <c:pt idx="4">
                  <c:v>4.8499999999999996</c:v>
                </c:pt>
                <c:pt idx="5">
                  <c:v>4.55</c:v>
                </c:pt>
                <c:pt idx="6">
                  <c:v>3.98</c:v>
                </c:pt>
                <c:pt idx="7">
                  <c:v>3.09</c:v>
                </c:pt>
                <c:pt idx="8">
                  <c:v>3.06</c:v>
                </c:pt>
                <c:pt idx="9">
                  <c:v>2.5499999999999998</c:v>
                </c:pt>
                <c:pt idx="10">
                  <c:v>2.39</c:v>
                </c:pt>
                <c:pt idx="11">
                  <c:v>2.35</c:v>
                </c:pt>
                <c:pt idx="12">
                  <c:v>2.25</c:v>
                </c:pt>
                <c:pt idx="13">
                  <c:v>2.19</c:v>
                </c:pt>
                <c:pt idx="14">
                  <c:v>1.91</c:v>
                </c:pt>
                <c:pt idx="15">
                  <c:v>1.79</c:v>
                </c:pt>
                <c:pt idx="16">
                  <c:v>1.74</c:v>
                </c:pt>
                <c:pt idx="17">
                  <c:v>1.59</c:v>
                </c:pt>
                <c:pt idx="18">
                  <c:v>1.55</c:v>
                </c:pt>
                <c:pt idx="19">
                  <c:v>1.3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125-4A05-80A2-D708A0DDCF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38935168"/>
        <c:axId val="38936960"/>
      </c:barChart>
      <c:catAx>
        <c:axId val="38935168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38936960"/>
        <c:crosses val="autoZero"/>
        <c:auto val="1"/>
        <c:lblAlgn val="ctr"/>
        <c:lblOffset val="100"/>
        <c:noMultiLvlLbl val="0"/>
      </c:catAx>
      <c:valAx>
        <c:axId val="38936960"/>
        <c:scaling>
          <c:orientation val="minMax"/>
          <c:max val="10"/>
        </c:scaling>
        <c:delete val="0"/>
        <c:axPos val="t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-log(p-value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38935168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rgbClr val="FF0000">
                <a:alpha val="50000"/>
              </a:srgb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0!$A$3:$A$20</c:f>
              <c:strCache>
                <c:ptCount val="18"/>
                <c:pt idx="0">
                  <c:v>Renal Necrosis/Cell Death</c:v>
                </c:pt>
                <c:pt idx="1">
                  <c:v>Mitochondrial Dysfunction</c:v>
                </c:pt>
                <c:pt idx="2">
                  <c:v>p53 Signaling</c:v>
                </c:pt>
                <c:pt idx="3">
                  <c:v>Anti-Apoptosis</c:v>
                </c:pt>
                <c:pt idx="4">
                  <c:v>Decreases Depolarization of Mitochondria and Mitochondrial Membrane</c:v>
                </c:pt>
                <c:pt idx="5">
                  <c:v>PXR/RXR Activation</c:v>
                </c:pt>
                <c:pt idx="6">
                  <c:v>Oxidative Stress</c:v>
                </c:pt>
                <c:pt idx="7">
                  <c:v>RAR Activation</c:v>
                </c:pt>
                <c:pt idx="8">
                  <c:v>Cell Cycle: G2/M DNA Damage Checkpoint Regulation</c:v>
                </c:pt>
                <c:pt idx="9">
                  <c:v>Decreases Transmembrane Potential of Mitochondria and Mitochondrial Membrane</c:v>
                </c:pt>
                <c:pt idx="10">
                  <c:v>TR/RXR Activation</c:v>
                </c:pt>
                <c:pt idx="11">
                  <c:v>Cardiac Necrosis/Cell Death</c:v>
                </c:pt>
                <c:pt idx="12">
                  <c:v>Cell Cycle: G1/S Checkpoint Regulation</c:v>
                </c:pt>
                <c:pt idx="13">
                  <c:v>Fatty Acid Metabolism</c:v>
                </c:pt>
                <c:pt idx="14">
                  <c:v>Hypoxia-Inducible Factor Signaling</c:v>
                </c:pt>
                <c:pt idx="15">
                  <c:v>Cardiac Hypertrophy</c:v>
                </c:pt>
                <c:pt idx="16">
                  <c:v>Increases Transmembrane Potential of Mitochondria and Mitochondrial Membrane</c:v>
                </c:pt>
                <c:pt idx="17">
                  <c:v>Increases Liver Hyperplasia/Hyperproliferation</c:v>
                </c:pt>
              </c:strCache>
            </c:strRef>
          </c:cat>
          <c:val>
            <c:numRef>
              <c:f>Sheet0!$B$3:$B$20</c:f>
              <c:numCache>
                <c:formatCode>General</c:formatCode>
                <c:ptCount val="18"/>
                <c:pt idx="0">
                  <c:v>4.76</c:v>
                </c:pt>
                <c:pt idx="1">
                  <c:v>3.62</c:v>
                </c:pt>
                <c:pt idx="2">
                  <c:v>2.82</c:v>
                </c:pt>
                <c:pt idx="3">
                  <c:v>2.79</c:v>
                </c:pt>
                <c:pt idx="4">
                  <c:v>2.73</c:v>
                </c:pt>
                <c:pt idx="5">
                  <c:v>2.72</c:v>
                </c:pt>
                <c:pt idx="6">
                  <c:v>2.35</c:v>
                </c:pt>
                <c:pt idx="7">
                  <c:v>2.15</c:v>
                </c:pt>
                <c:pt idx="8">
                  <c:v>1.87</c:v>
                </c:pt>
                <c:pt idx="9">
                  <c:v>1.6</c:v>
                </c:pt>
                <c:pt idx="10">
                  <c:v>1.54</c:v>
                </c:pt>
                <c:pt idx="11">
                  <c:v>1.46</c:v>
                </c:pt>
                <c:pt idx="12">
                  <c:v>1.45</c:v>
                </c:pt>
                <c:pt idx="13">
                  <c:v>1.4</c:v>
                </c:pt>
                <c:pt idx="14">
                  <c:v>1.4</c:v>
                </c:pt>
                <c:pt idx="15">
                  <c:v>1.35</c:v>
                </c:pt>
                <c:pt idx="16">
                  <c:v>1.33</c:v>
                </c:pt>
                <c:pt idx="17">
                  <c:v>1.3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4F5-4390-BF3D-D0009AAB07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38961536"/>
        <c:axId val="38963072"/>
      </c:barChart>
      <c:catAx>
        <c:axId val="38961536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38963072"/>
        <c:crosses val="autoZero"/>
        <c:auto val="1"/>
        <c:lblAlgn val="ctr"/>
        <c:lblOffset val="100"/>
        <c:noMultiLvlLbl val="0"/>
      </c:catAx>
      <c:valAx>
        <c:axId val="38963072"/>
        <c:scaling>
          <c:orientation val="minMax"/>
          <c:max val="10"/>
        </c:scaling>
        <c:delete val="0"/>
        <c:axPos val="t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-log(p-value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38961536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0!$A$3:$A$13</c:f>
              <c:strCache>
                <c:ptCount val="11"/>
                <c:pt idx="0">
                  <c:v>Fatty Acid Metabolism</c:v>
                </c:pt>
                <c:pt idx="1">
                  <c:v>Cholesterol Biosynthesis</c:v>
                </c:pt>
                <c:pt idx="2">
                  <c:v>Genes associated with Chronic Allograft Nephropathy (Human)</c:v>
                </c:pt>
                <c:pt idx="3">
                  <c:v>Mitochondrial Dysfunction</c:v>
                </c:pt>
                <c:pt idx="4">
                  <c:v>Cardiac Necrosis/Cell Death</c:v>
                </c:pt>
                <c:pt idx="5">
                  <c:v>Increases Liver Hyperplasia/Hyperproliferation</c:v>
                </c:pt>
                <c:pt idx="6">
                  <c:v>LXR/RXR Activation</c:v>
                </c:pt>
                <c:pt idx="7">
                  <c:v>Anti-Apoptosis</c:v>
                </c:pt>
                <c:pt idx="8">
                  <c:v>RAR Activation</c:v>
                </c:pt>
                <c:pt idx="9">
                  <c:v>Decreases Depolarization of Mitochondria and Mitochondrial Membrane</c:v>
                </c:pt>
                <c:pt idx="10">
                  <c:v>Renal Necrosis/Cell Death</c:v>
                </c:pt>
              </c:strCache>
            </c:strRef>
          </c:cat>
          <c:val>
            <c:numRef>
              <c:f>Sheet0!$B$3:$B$13</c:f>
              <c:numCache>
                <c:formatCode>General</c:formatCode>
                <c:ptCount val="11"/>
                <c:pt idx="0">
                  <c:v>2.3199999999999998</c:v>
                </c:pt>
                <c:pt idx="1">
                  <c:v>2.0099999999999998</c:v>
                </c:pt>
                <c:pt idx="2">
                  <c:v>1.78</c:v>
                </c:pt>
                <c:pt idx="3">
                  <c:v>1.65</c:v>
                </c:pt>
                <c:pt idx="4">
                  <c:v>1.64</c:v>
                </c:pt>
                <c:pt idx="5">
                  <c:v>1.56</c:v>
                </c:pt>
                <c:pt idx="6">
                  <c:v>1.54</c:v>
                </c:pt>
                <c:pt idx="7">
                  <c:v>1.44</c:v>
                </c:pt>
                <c:pt idx="8">
                  <c:v>1.44</c:v>
                </c:pt>
                <c:pt idx="9">
                  <c:v>1.42</c:v>
                </c:pt>
                <c:pt idx="10">
                  <c:v>1.3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4BC-48C1-80CA-52C8CAA64D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38975360"/>
        <c:axId val="38976896"/>
      </c:barChart>
      <c:catAx>
        <c:axId val="38975360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38976896"/>
        <c:crosses val="autoZero"/>
        <c:auto val="1"/>
        <c:lblAlgn val="ctr"/>
        <c:lblOffset val="100"/>
        <c:noMultiLvlLbl val="0"/>
      </c:catAx>
      <c:valAx>
        <c:axId val="38976896"/>
        <c:scaling>
          <c:orientation val="minMax"/>
          <c:max val="10"/>
        </c:scaling>
        <c:delete val="0"/>
        <c:axPos val="t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-log(p-value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38975360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0!$A$3:$A$13</c:f>
              <c:strCache>
                <c:ptCount val="11"/>
                <c:pt idx="0">
                  <c:v>Mitochondrial Dysfunction</c:v>
                </c:pt>
                <c:pt idx="1">
                  <c:v>Renal Necrosis/Cell Death</c:v>
                </c:pt>
                <c:pt idx="2">
                  <c:v>NRF2-mediated Oxidative Stress Response</c:v>
                </c:pt>
                <c:pt idx="3">
                  <c:v>Cardiac Necrosis/Cell Death</c:v>
                </c:pt>
                <c:pt idx="4">
                  <c:v>Cholesterol Biosynthesis</c:v>
                </c:pt>
                <c:pt idx="5">
                  <c:v>Renal Glomerulus Panel (Human)</c:v>
                </c:pt>
                <c:pt idx="6">
                  <c:v>Hypoxia-Inducible Factor Signaling</c:v>
                </c:pt>
                <c:pt idx="7">
                  <c:v>Oxidative Stress</c:v>
                </c:pt>
                <c:pt idx="8">
                  <c:v>Xenobiotic Metabolism Signaling</c:v>
                </c:pt>
                <c:pt idx="9">
                  <c:v>RAR Activation</c:v>
                </c:pt>
                <c:pt idx="10">
                  <c:v>Mechanism of Gene Regulation by Peroxisome Proliferators via PPARα</c:v>
                </c:pt>
              </c:strCache>
            </c:strRef>
          </c:cat>
          <c:val>
            <c:numRef>
              <c:f>Sheet0!$B$3:$B$13</c:f>
              <c:numCache>
                <c:formatCode>General</c:formatCode>
                <c:ptCount val="11"/>
                <c:pt idx="0">
                  <c:v>9.27</c:v>
                </c:pt>
                <c:pt idx="1">
                  <c:v>4.0999999999999996</c:v>
                </c:pt>
                <c:pt idx="2">
                  <c:v>3.82</c:v>
                </c:pt>
                <c:pt idx="3">
                  <c:v>3.42</c:v>
                </c:pt>
                <c:pt idx="4">
                  <c:v>3.08</c:v>
                </c:pt>
                <c:pt idx="5">
                  <c:v>1.96</c:v>
                </c:pt>
                <c:pt idx="6">
                  <c:v>1.87</c:v>
                </c:pt>
                <c:pt idx="7">
                  <c:v>1.67</c:v>
                </c:pt>
                <c:pt idx="8">
                  <c:v>1.43</c:v>
                </c:pt>
                <c:pt idx="9">
                  <c:v>1.33</c:v>
                </c:pt>
                <c:pt idx="10">
                  <c:v>1.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004-AE40-9ED3-8D3DFA22A8D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39075200"/>
        <c:axId val="39089280"/>
      </c:barChart>
      <c:catAx>
        <c:axId val="39075200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39089280"/>
        <c:crosses val="autoZero"/>
        <c:auto val="1"/>
        <c:lblAlgn val="ctr"/>
        <c:lblOffset val="100"/>
        <c:noMultiLvlLbl val="0"/>
      </c:catAx>
      <c:valAx>
        <c:axId val="39089280"/>
        <c:scaling>
          <c:orientation val="minMax"/>
        </c:scaling>
        <c:delete val="0"/>
        <c:axPos val="t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-log(</a:t>
                </a:r>
                <a:r>
                  <a:rPr lang="en-US" i="1"/>
                  <a:t>p</a:t>
                </a:r>
                <a:r>
                  <a:rPr lang="en-US"/>
                  <a:t>-value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390752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6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862" y="1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67C758-A4EB-4A41-8BAB-A84C94E459BF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383" y="4776856"/>
            <a:ext cx="5436909" cy="390895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273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862" y="9428273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F47CAC-7AD0-4285-B834-8E3EF591295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9455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4403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13360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09811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1381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3155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49209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90022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0109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887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7349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486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43675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74615975"/>
              </p:ext>
            </p:extLst>
          </p:nvPr>
        </p:nvGraphicFramePr>
        <p:xfrm>
          <a:off x="152400" y="426720"/>
          <a:ext cx="3600000" cy="24688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25975233"/>
              </p:ext>
            </p:extLst>
          </p:nvPr>
        </p:nvGraphicFramePr>
        <p:xfrm>
          <a:off x="165410" y="2743200"/>
          <a:ext cx="360000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65408" y="507433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402300" y="1775976"/>
            <a:ext cx="5613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>
                <a:latin typeface="Arial" panose="020B0604020202020204" pitchFamily="34" charset="0"/>
                <a:cs typeface="Arial" panose="020B0604020202020204" pitchFamily="34" charset="0"/>
              </a:rPr>
              <a:t> ● AUY922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810615" y="3883700"/>
            <a:ext cx="484428" cy="184666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600">
                <a:solidFill>
                  <a:srgbClr val="FF0000">
                    <a:alpha val="50000"/>
                  </a:srgb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■</a:t>
            </a:r>
            <a:r>
              <a:rPr lang="en-US" sz="6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>
                <a:latin typeface="Arial" panose="020B0604020202020204" pitchFamily="34" charset="0"/>
                <a:cs typeface="Arial" panose="020B0604020202020204" pitchFamily="34" charset="0"/>
              </a:rPr>
              <a:t>VE821</a:t>
            </a:r>
            <a:endParaRPr lang="en-US" sz="6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65408" y="2862757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14232655"/>
              </p:ext>
            </p:extLst>
          </p:nvPr>
        </p:nvGraphicFramePr>
        <p:xfrm>
          <a:off x="152710" y="4953000"/>
          <a:ext cx="3600000" cy="16459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3" name="TextBox 12"/>
          <p:cNvSpPr txBox="1"/>
          <p:nvPr/>
        </p:nvSpPr>
        <p:spPr>
          <a:xfrm>
            <a:off x="152710" y="500961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438710" y="5878910"/>
            <a:ext cx="76174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●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AUY-VE (208)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697268" y="49141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5" name="TextBox 19">
            <a:extLst>
              <a:ext uri="{FF2B5EF4-FFF2-40B4-BE49-F238E27FC236}">
                <a16:creationId xmlns:a16="http://schemas.microsoft.com/office/drawing/2014/main" xmlns="" id="{57550D90-B9BD-FB49-B43F-213367B638F1}"/>
              </a:ext>
            </a:extLst>
          </p:cNvPr>
          <p:cNvSpPr txBox="1"/>
          <p:nvPr/>
        </p:nvSpPr>
        <p:spPr>
          <a:xfrm>
            <a:off x="3750619" y="320040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aphicFrame>
        <p:nvGraphicFramePr>
          <p:cNvPr id="18" name="Chart 12">
            <a:extLst>
              <a:ext uri="{FF2B5EF4-FFF2-40B4-BE49-F238E27FC236}">
                <a16:creationId xmlns:a16="http://schemas.microsoft.com/office/drawing/2014/main" xmlns="" id="{05C8CB39-2863-F64E-8BA1-C81ADE46072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36090250"/>
              </p:ext>
            </p:extLst>
          </p:nvPr>
        </p:nvGraphicFramePr>
        <p:xfrm>
          <a:off x="169892" y="6553200"/>
          <a:ext cx="3600000" cy="169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9" name="TextBox 23">
            <a:extLst>
              <a:ext uri="{FF2B5EF4-FFF2-40B4-BE49-F238E27FC236}">
                <a16:creationId xmlns:a16="http://schemas.microsoft.com/office/drawing/2014/main" xmlns="" id="{BB68622D-8FC3-CC4D-BC9D-B2DCCCA0BCDA}"/>
              </a:ext>
            </a:extLst>
          </p:cNvPr>
          <p:cNvSpPr txBox="1"/>
          <p:nvPr/>
        </p:nvSpPr>
        <p:spPr>
          <a:xfrm>
            <a:off x="169892" y="6588319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0" name="TextBox 15">
            <a:extLst>
              <a:ext uri="{FF2B5EF4-FFF2-40B4-BE49-F238E27FC236}">
                <a16:creationId xmlns:a16="http://schemas.microsoft.com/office/drawing/2014/main" xmlns="" id="{5E124517-6FED-5B45-A424-775421B39C60}"/>
              </a:ext>
            </a:extLst>
          </p:cNvPr>
          <p:cNvSpPr txBox="1"/>
          <p:nvPr/>
        </p:nvSpPr>
        <p:spPr>
          <a:xfrm>
            <a:off x="2313151" y="7571853"/>
            <a:ext cx="103746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●</a:t>
            </a:r>
            <a:r>
              <a:rPr lang="en-US" sz="600">
                <a:latin typeface="Arial" panose="020B0604020202020204" pitchFamily="34" charset="0"/>
                <a:cs typeface="Arial" panose="020B0604020202020204" pitchFamily="34" charset="0"/>
              </a:rPr>
              <a:t> AUY-VE unique (630) </a:t>
            </a:r>
          </a:p>
        </p:txBody>
      </p:sp>
      <p:sp>
        <p:nvSpPr>
          <p:cNvPr id="9" name="Rechteck 8">
            <a:extLst>
              <a:ext uri="{FF2B5EF4-FFF2-40B4-BE49-F238E27FC236}">
                <a16:creationId xmlns:a16="http://schemas.microsoft.com/office/drawing/2014/main" xmlns="" id="{55ABAC3B-446B-6940-80D5-AA23D055BBCB}"/>
              </a:ext>
            </a:extLst>
          </p:cNvPr>
          <p:cNvSpPr/>
          <p:nvPr/>
        </p:nvSpPr>
        <p:spPr>
          <a:xfrm>
            <a:off x="247042" y="8280319"/>
            <a:ext cx="6229957" cy="14465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10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Ingenuity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pathway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proteome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t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A673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45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UY922 ± 2 µM VE821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24 h, and a quantitative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hol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roteom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on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mas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pectrometr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hre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individual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experiment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roteom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e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urthe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rocess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ngenuit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athwa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(IPA;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utof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&lt;0.05)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oxicitie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fter AUY922 (A)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VE821 (B)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reatment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ommo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e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208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verlapping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ifferentiall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express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rotein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(DEPs)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etwee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UY922-VE821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ombination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(AUY-VE)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ingl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reatment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rocess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IPA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isease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io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unction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(C)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oxicitie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(D). The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uniqu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e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630 DEPs after AUY-VE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reatment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rocess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IPA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isease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io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unction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(E)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oxicitie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(F). </a:t>
            </a:r>
          </a:p>
        </p:txBody>
      </p:sp>
      <p:graphicFrame>
        <p:nvGraphicFramePr>
          <p:cNvPr id="10" name="Tabl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78107447"/>
              </p:ext>
            </p:extLst>
          </p:nvPr>
        </p:nvGraphicFramePr>
        <p:xfrm>
          <a:off x="3992542" y="626603"/>
          <a:ext cx="1944000" cy="2124100"/>
        </p:xfrm>
        <a:graphic>
          <a:graphicData uri="http://schemas.openxmlformats.org/drawingml/2006/table">
            <a:tbl>
              <a:tblPr/>
              <a:tblGrid>
                <a:gridCol w="1620000">
                  <a:extLst>
                    <a:ext uri="{9D8B030D-6E8A-4147-A177-3AD203B41FA5}">
                      <a16:colId xmlns:a16="http://schemas.microsoft.com/office/drawing/2014/main" xmlns="" val="2363652887"/>
                    </a:ext>
                  </a:extLst>
                </a:gridCol>
                <a:gridCol w="324000">
                  <a:extLst>
                    <a:ext uri="{9D8B030D-6E8A-4147-A177-3AD203B41FA5}">
                      <a16:colId xmlns:a16="http://schemas.microsoft.com/office/drawing/2014/main" xmlns="" val="1103251013"/>
                    </a:ext>
                  </a:extLst>
                </a:gridCol>
              </a:tblGrid>
              <a:tr h="180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eases and Bio Functions (208)</a:t>
                      </a:r>
                    </a:p>
                  </a:txBody>
                  <a:tcPr marL="5765" marR="5765" marT="576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 panose="020B0604020202020204" pitchFamily="34" charset="0"/>
                        </a:rPr>
                        <a:t>AUY-VE</a:t>
                      </a:r>
                    </a:p>
                  </a:txBody>
                  <a:tcPr marL="5765" marR="5765" marT="576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55274614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proliferation of tumor cell lines</a:t>
                      </a:r>
                    </a:p>
                  </a:txBody>
                  <a:tcPr marL="5765" marR="5765" marT="576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65" marR="5765" marT="576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4472C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720459839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ptosis</a:t>
                      </a:r>
                    </a:p>
                  </a:txBody>
                  <a:tcPr marL="5765" marR="5765" marT="576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65" marR="5765" marT="576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320970501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ptosis of cervical cancer cell lines</a:t>
                      </a:r>
                    </a:p>
                  </a:txBody>
                  <a:tcPr marL="5765" marR="5765" marT="576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65" marR="5765" marT="576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6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13083196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death of cervical cancer cell lines</a:t>
                      </a:r>
                    </a:p>
                  </a:txBody>
                  <a:tcPr marL="5765" marR="5765" marT="576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65" marR="5765" marT="576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F8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627669717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crosis</a:t>
                      </a:r>
                    </a:p>
                  </a:txBody>
                  <a:tcPr marL="5765" marR="5765" marT="576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65" marR="5765" marT="576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172568964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proliferation of colorectal cancer cell lines</a:t>
                      </a:r>
                    </a:p>
                  </a:txBody>
                  <a:tcPr marL="5765" marR="5765" marT="576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65" marR="5765" marT="576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6599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571382373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wth of tumor</a:t>
                      </a:r>
                    </a:p>
                  </a:txBody>
                  <a:tcPr marL="5765" marR="5765" marT="576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65" marR="5765" marT="576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370C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666552509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tokinesis</a:t>
                      </a:r>
                    </a:p>
                  </a:txBody>
                  <a:tcPr marL="5765" marR="5765" marT="576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65" marR="5765" marT="576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85DA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710295808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ganismal death</a:t>
                      </a:r>
                    </a:p>
                  </a:txBody>
                  <a:tcPr marL="5765" marR="5765" marT="576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65" marR="5765" marT="576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F9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605958514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ral Infection</a:t>
                      </a:r>
                    </a:p>
                  </a:txBody>
                  <a:tcPr marL="5765" marR="5765" marT="576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65" marR="5765" marT="576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06BB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560714567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ptosis of tumor cell lines</a:t>
                      </a:r>
                    </a:p>
                  </a:txBody>
                  <a:tcPr marL="5765" marR="5765" marT="576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65" marR="5765" marT="576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FD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945496525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 phase</a:t>
                      </a:r>
                    </a:p>
                  </a:txBody>
                  <a:tcPr marL="5765" marR="5765" marT="576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65" marR="5765" marT="576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F4F8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295976619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death of tumor cell lines</a:t>
                      </a:r>
                    </a:p>
                  </a:txBody>
                  <a:tcPr marL="5765" marR="5765" marT="576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65" marR="5765" marT="576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624496187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viability of breast cancer cell lines</a:t>
                      </a:r>
                    </a:p>
                  </a:txBody>
                  <a:tcPr marL="5765" marR="5765" marT="576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65" marR="5765" marT="576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4579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67631745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vanced malignant tumor</a:t>
                      </a:r>
                    </a:p>
                  </a:txBody>
                  <a:tcPr marL="5765" marR="5765" marT="576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65" marR="5765" marT="576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5589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98812287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condary tumor</a:t>
                      </a:r>
                    </a:p>
                  </a:txBody>
                  <a:tcPr marL="5765" marR="5765" marT="576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65" marR="5765" marT="576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5589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577700419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omosomal aberration</a:t>
                      </a:r>
                    </a:p>
                  </a:txBody>
                  <a:tcPr marL="5765" marR="5765" marT="576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65" marR="5765" marT="576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5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837055793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tokinesis of tumor cell lines</a:t>
                      </a:r>
                    </a:p>
                  </a:txBody>
                  <a:tcPr marL="5765" marR="5765" marT="576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65" marR="5765" marT="576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D4B8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100134778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movement of fibroblast cell lines</a:t>
                      </a:r>
                    </a:p>
                  </a:txBody>
                  <a:tcPr marL="5765" marR="5765" marT="576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65" marR="5765" marT="576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D4A8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322235730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plication of virus</a:t>
                      </a:r>
                    </a:p>
                  </a:txBody>
                  <a:tcPr marL="5765" marR="5765" marT="576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765" marR="5765" marT="576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1518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837567188"/>
                  </a:ext>
                </a:extLst>
              </a:tr>
            </a:tbl>
          </a:graphicData>
        </a:graphic>
      </p:graphicFrame>
      <p:graphicFrame>
        <p:nvGraphicFramePr>
          <p:cNvPr id="11" name="Tab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14302283"/>
              </p:ext>
            </p:extLst>
          </p:nvPr>
        </p:nvGraphicFramePr>
        <p:xfrm>
          <a:off x="5216542" y="2798897"/>
          <a:ext cx="720000" cy="302895"/>
        </p:xfrm>
        <a:graphic>
          <a:graphicData uri="http://schemas.openxmlformats.org/drawingml/2006/table">
            <a:tbl>
              <a:tblPr/>
              <a:tblGrid>
                <a:gridCol w="144000">
                  <a:extLst>
                    <a:ext uri="{9D8B030D-6E8A-4147-A177-3AD203B41FA5}">
                      <a16:colId xmlns:a16="http://schemas.microsoft.com/office/drawing/2014/main" xmlns="" val="1328409617"/>
                    </a:ext>
                  </a:extLst>
                </a:gridCol>
                <a:gridCol w="144000">
                  <a:extLst>
                    <a:ext uri="{9D8B030D-6E8A-4147-A177-3AD203B41FA5}">
                      <a16:colId xmlns:a16="http://schemas.microsoft.com/office/drawing/2014/main" xmlns="" val="3723506152"/>
                    </a:ext>
                  </a:extLst>
                </a:gridCol>
                <a:gridCol w="144000">
                  <a:extLst>
                    <a:ext uri="{9D8B030D-6E8A-4147-A177-3AD203B41FA5}">
                      <a16:colId xmlns:a16="http://schemas.microsoft.com/office/drawing/2014/main" xmlns="" val="425275195"/>
                    </a:ext>
                  </a:extLst>
                </a:gridCol>
                <a:gridCol w="144000">
                  <a:extLst>
                    <a:ext uri="{9D8B030D-6E8A-4147-A177-3AD203B41FA5}">
                      <a16:colId xmlns:a16="http://schemas.microsoft.com/office/drawing/2014/main" xmlns="" val="2229462141"/>
                    </a:ext>
                  </a:extLst>
                </a:gridCol>
                <a:gridCol w="144000">
                  <a:extLst>
                    <a:ext uri="{9D8B030D-6E8A-4147-A177-3AD203B41FA5}">
                      <a16:colId xmlns:a16="http://schemas.microsoft.com/office/drawing/2014/main" xmlns="" val="4030823480"/>
                    </a:ext>
                  </a:extLst>
                </a:gridCol>
              </a:tblGrid>
              <a:tr h="36000"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-scor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789493016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7264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54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265523769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87379264"/>
                  </a:ext>
                </a:extLst>
              </a:tr>
            </a:tbl>
          </a:graphicData>
        </a:graphic>
      </p:graphicFrame>
      <p:graphicFrame>
        <p:nvGraphicFramePr>
          <p:cNvPr id="21" name="Table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3169068"/>
              </p:ext>
            </p:extLst>
          </p:nvPr>
        </p:nvGraphicFramePr>
        <p:xfrm>
          <a:off x="4033193" y="3353811"/>
          <a:ext cx="1944000" cy="2235300"/>
        </p:xfrm>
        <a:graphic>
          <a:graphicData uri="http://schemas.openxmlformats.org/drawingml/2006/table">
            <a:tbl>
              <a:tblPr/>
              <a:tblGrid>
                <a:gridCol w="1620000">
                  <a:extLst>
                    <a:ext uri="{9D8B030D-6E8A-4147-A177-3AD203B41FA5}">
                      <a16:colId xmlns:a16="http://schemas.microsoft.com/office/drawing/2014/main" xmlns="" val="3926961747"/>
                    </a:ext>
                  </a:extLst>
                </a:gridCol>
                <a:gridCol w="324000">
                  <a:extLst>
                    <a:ext uri="{9D8B030D-6E8A-4147-A177-3AD203B41FA5}">
                      <a16:colId xmlns:a16="http://schemas.microsoft.com/office/drawing/2014/main" xmlns="" val="3889348472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eases and Bio Functions (630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Arial" panose="020B0604020202020204" pitchFamily="34" charset="0"/>
                        </a:rPr>
                        <a:t>AUY-VE uniqu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077740451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urviva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426FB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825680986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viabilit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471C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766191089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proliferation of tumor cell lin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960A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231771971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death of tumor cell lin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F9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596671984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viability of tumor cell lin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65A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127855804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ganization of cytoplas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F6AB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362518772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ganization of cytoskeleto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F6AB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207900265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ral Infectio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65A9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580982736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tension of cellular protrusion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1518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112596814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rbidity or mortalit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1D1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59724790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ganismal death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FC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700925745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mation of cellular protrusion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2549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989994946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rotubule dynamic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1518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575597967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tension of neurit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7427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2312598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ptosi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0B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836288725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nsport of protei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C4A7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301621818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pair of DN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F345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18291461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transformatio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A477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554274992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mation of gamma H2AX nuclear focu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565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151470545"/>
                  </a:ext>
                </a:extLst>
              </a:tr>
              <a:tr h="72000"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tosi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8437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775466070"/>
                  </a:ext>
                </a:extLst>
              </a:tr>
            </a:tbl>
          </a:graphicData>
        </a:graphic>
      </p:graphicFrame>
      <p:graphicFrame>
        <p:nvGraphicFramePr>
          <p:cNvPr id="27" name="Table 2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1998331"/>
              </p:ext>
            </p:extLst>
          </p:nvPr>
        </p:nvGraphicFramePr>
        <p:xfrm>
          <a:off x="5261742" y="5624512"/>
          <a:ext cx="720000" cy="302895"/>
        </p:xfrm>
        <a:graphic>
          <a:graphicData uri="http://schemas.openxmlformats.org/drawingml/2006/table">
            <a:tbl>
              <a:tblPr/>
              <a:tblGrid>
                <a:gridCol w="144000">
                  <a:extLst>
                    <a:ext uri="{9D8B030D-6E8A-4147-A177-3AD203B41FA5}">
                      <a16:colId xmlns:a16="http://schemas.microsoft.com/office/drawing/2014/main" xmlns="" val="1328409617"/>
                    </a:ext>
                  </a:extLst>
                </a:gridCol>
                <a:gridCol w="144000">
                  <a:extLst>
                    <a:ext uri="{9D8B030D-6E8A-4147-A177-3AD203B41FA5}">
                      <a16:colId xmlns:a16="http://schemas.microsoft.com/office/drawing/2014/main" xmlns="" val="3723506152"/>
                    </a:ext>
                  </a:extLst>
                </a:gridCol>
                <a:gridCol w="144000">
                  <a:extLst>
                    <a:ext uri="{9D8B030D-6E8A-4147-A177-3AD203B41FA5}">
                      <a16:colId xmlns:a16="http://schemas.microsoft.com/office/drawing/2014/main" xmlns="" val="425275195"/>
                    </a:ext>
                  </a:extLst>
                </a:gridCol>
                <a:gridCol w="144000">
                  <a:extLst>
                    <a:ext uri="{9D8B030D-6E8A-4147-A177-3AD203B41FA5}">
                      <a16:colId xmlns:a16="http://schemas.microsoft.com/office/drawing/2014/main" xmlns="" val="2229462141"/>
                    </a:ext>
                  </a:extLst>
                </a:gridCol>
                <a:gridCol w="144000">
                  <a:extLst>
                    <a:ext uri="{9D8B030D-6E8A-4147-A177-3AD203B41FA5}">
                      <a16:colId xmlns:a16="http://schemas.microsoft.com/office/drawing/2014/main" xmlns="" val="4030823480"/>
                    </a:ext>
                  </a:extLst>
                </a:gridCol>
              </a:tblGrid>
              <a:tr h="36000"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-scor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789493016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7264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454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265523769"/>
                  </a:ext>
                </a:extLst>
              </a:tr>
              <a:tr h="36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87379264"/>
                  </a:ext>
                </a:extLst>
              </a:tr>
            </a:tbl>
          </a:graphicData>
        </a:graphic>
      </p:graphicFrame>
      <p:sp>
        <p:nvSpPr>
          <p:cNvPr id="22" name="TextBox 1"/>
          <p:cNvSpPr txBox="1"/>
          <p:nvPr/>
        </p:nvSpPr>
        <p:spPr>
          <a:xfrm>
            <a:off x="-13746" y="0"/>
            <a:ext cx="224773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orting Figure 10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597102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2</Words>
  <Application>Microsoft Office PowerPoint</Application>
  <PresentationFormat>A4-Papier (210x297 mm)</PresentationFormat>
  <Paragraphs>72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 Theme</vt:lpstr>
      <vt:lpstr>PowerPoint-Präsentation</vt:lpstr>
    </vt:vector>
  </TitlesOfParts>
  <Company>FL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an Marx</dc:creator>
  <cp:lastModifiedBy>Sonnemann, Jürgen</cp:lastModifiedBy>
  <cp:revision>1138</cp:revision>
  <cp:lastPrinted>2020-12-23T12:22:31Z</cp:lastPrinted>
  <dcterms:created xsi:type="dcterms:W3CDTF">2018-06-28T13:36:42Z</dcterms:created>
  <dcterms:modified xsi:type="dcterms:W3CDTF">2021-02-25T08:15:26Z</dcterms:modified>
</cp:coreProperties>
</file>